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3" d="100"/>
          <a:sy n="93" d="100"/>
        </p:scale>
        <p:origin x="2478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531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5233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2636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8923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302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3526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8973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2642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2049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1006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1789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9242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-8763" y="35496"/>
            <a:ext cx="6822139" cy="11371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upplementary Figure 3A: 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djusted (for the mean of all other variables of the model) hazard ratio of event (failure, relapse or death) for each value of CD34+CD38-CD123+ percentage. After adjustment for confounding factors (age, albumin, cytogenetic risk at diagnosis and allogeneic stem-cell transplantation), event rate significantly (P=0.0001) increased from CD34+CD38-CD123+ percentage &gt; 10% in patients treated with Intensive Chemotherapy. </a:t>
            </a:r>
            <a:r>
              <a:rPr lang="fr-FR" sz="1200" dirty="0" err="1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Dashed</a:t>
            </a:r>
            <a:r>
              <a:rPr lang="fr-FR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lines</a:t>
            </a:r>
            <a:r>
              <a:rPr lang="fr-FR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correspond to 95% confidence </a:t>
            </a:r>
            <a:r>
              <a:rPr lang="fr-FR" sz="1200" dirty="0" err="1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interval</a:t>
            </a:r>
            <a:r>
              <a:rPr lang="fr-FR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of </a:t>
            </a:r>
            <a:r>
              <a:rPr lang="fr-FR" sz="1200" dirty="0" err="1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hazard</a:t>
            </a:r>
            <a:r>
              <a:rPr lang="fr-FR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ratio.</a:t>
            </a:r>
            <a:endParaRPr lang="fr-FR" sz="160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</p:txBody>
      </p:sp>
      <p:pic>
        <p:nvPicPr>
          <p:cNvPr id="7" name="Image 6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1248" y="1172601"/>
            <a:ext cx="4680000" cy="32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Image 8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1248" y="5813192"/>
            <a:ext cx="4680000" cy="3240000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Rectangle 9"/>
          <p:cNvSpPr/>
          <p:nvPr/>
        </p:nvSpPr>
        <p:spPr>
          <a:xfrm>
            <a:off x="-8763" y="4427984"/>
            <a:ext cx="6822139" cy="1154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upplementary Figure 3B: 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djusted (for the mean of all other variables of the model) hazard ratio of relapse for each value of CD34+CD38-CD123+ percentage. After adjustment for confounding factors (allogeneic stem-cell transplantation), relapse rate significantly (P&lt;0.0001) increased from CD34+CD38-CD123+ percentage &gt; 10% in patients treated with Intensive Chemotherapy. Dashed lines correspond to 95% confidence interval of hazard ratio.</a:t>
            </a:r>
            <a:endParaRPr lang="fr-FR" sz="160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99657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7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ete</dc:creator>
  <cp:lastModifiedBy>François Vergez</cp:lastModifiedBy>
  <cp:revision>7</cp:revision>
  <cp:lastPrinted>2019-05-27T14:35:17Z</cp:lastPrinted>
  <dcterms:created xsi:type="dcterms:W3CDTF">2019-05-27T14:26:13Z</dcterms:created>
  <dcterms:modified xsi:type="dcterms:W3CDTF">2019-09-26T16:29:26Z</dcterms:modified>
</cp:coreProperties>
</file>